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459E2-46D9-4F75-81F2-1FDD24F1D5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EFEEB-6F63-4690-A038-183CD7D6EB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3D489-BBEA-41A8-B998-2F2D74471A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57090-59C9-424E-BD1E-6E537AAB69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C83914-ACDC-49EF-8E24-4525AA8A9A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8D794-AC06-4B5A-B439-C7DFF4A3EB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447E5-BAE3-4D2C-B191-83E71CDED5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E4C69-66F6-465A-895D-46C9924045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4C4BE-250F-47D8-BC0F-AC93F1DA6F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6B926-BBEA-4021-A084-024B88C80D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293AF-0F73-4918-8E31-F122FD1167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F137A9-863F-45BA-ACB6-25FC1D696D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6B1CD96-8786-44FF-AC35-61CBF70D840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835CC9A-159D-4E92-B950-EDE0AE65081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23880" y="2606760"/>
          <a:ext cx="6096240" cy="1646280"/>
        </p:xfrm>
        <a:graphic>
          <a:graphicData uri="http://schemas.openxmlformats.org/drawingml/2006/table">
            <a:tbl>
              <a:tblPr/>
              <a:tblGrid>
                <a:gridCol w="538200"/>
                <a:gridCol w="804960"/>
                <a:gridCol w="574560"/>
                <a:gridCol w="561960"/>
                <a:gridCol w="598680"/>
                <a:gridCol w="660240"/>
                <a:gridCol w="536760"/>
                <a:gridCol w="561960"/>
                <a:gridCol w="598320"/>
                <a:gridCol w="660600"/>
              </a:tblGrid>
              <a:tr h="185040"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 lIns="12240" rIns="12240" tIns="122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Hum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240" marR="122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12240" rIns="12240" tIns="122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Mou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240" marR="122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5040"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Ner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Musc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Liv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Cell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Ner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Musc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Liv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Cell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040">
                <a:tc rowSpan="4">
                  <a:txBody>
                    <a:bodyPr lIns="12240" rIns="12240" tIns="122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Hum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Ner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5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Musc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41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Liv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3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40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Cell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40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45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43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040">
                <a:tc rowSpan="4">
                  <a:txBody>
                    <a:bodyPr lIns="12240" rIns="12240" tIns="122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Mou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Ner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44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5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Musc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5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4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Liv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1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8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4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1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Cell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8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5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7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9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4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9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5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240" rIns="12240" tIns="1224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240" marR="1224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4"/>
          <p:cNvSpPr/>
          <p:nvPr/>
        </p:nvSpPr>
        <p:spPr>
          <a:xfrm>
            <a:off x="7205040" y="6299280"/>
            <a:ext cx="167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3T13:39:44Z</dcterms:created>
  <dc:creator>Holly Bradley</dc:creator>
  <dc:description/>
  <dc:language>en-US</dc:language>
  <cp:lastModifiedBy>Holly Bradley</cp:lastModifiedBy>
  <dcterms:modified xsi:type="dcterms:W3CDTF">2010-12-16T15:03:10Z</dcterms:modified>
  <cp:revision>2</cp:revision>
  <dc:subject/>
  <dc:title>Slide 1</dc:title>
</cp:coreProperties>
</file>